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ca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720"/>
  </p:normalViewPr>
  <p:slideViewPr>
    <p:cSldViewPr>
      <p:cViewPr varScale="1">
        <p:scale>
          <a:sx n="53" d="100"/>
          <a:sy n="53" d="100"/>
        </p:scale>
        <p:origin x="2046" y="39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ca-E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/>
              <a:t>Haga clic para modificar el estilo de subtítulo del patrón</a:t>
            </a:r>
            <a:endParaRPr lang="ca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3B5ABB-FBC5-4EF4-AFCB-CE15EC0E6C6E}" type="datetimeFigureOut">
              <a:rPr lang="ca-ES" smtClean="0"/>
              <a:t>6/8/2024</a:t>
            </a:fld>
            <a:endParaRPr lang="ca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FE8945-19B6-464E-93F7-C78A7EC10078}" type="slidenum">
              <a:rPr lang="ca-ES" smtClean="0"/>
              <a:t>‹Nº›</a:t>
            </a:fld>
            <a:endParaRPr lang="ca-E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ca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ca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3B5ABB-FBC5-4EF4-AFCB-CE15EC0E6C6E}" type="datetimeFigureOut">
              <a:rPr lang="ca-ES" smtClean="0"/>
              <a:t>6/8/2024</a:t>
            </a:fld>
            <a:endParaRPr lang="ca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FE8945-19B6-464E-93F7-C78A7EC10078}" type="slidenum">
              <a:rPr lang="ca-ES" smtClean="0"/>
              <a:t>‹Nº›</a:t>
            </a:fld>
            <a:endParaRPr lang="ca-E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ca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ca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3B5ABB-FBC5-4EF4-AFCB-CE15EC0E6C6E}" type="datetimeFigureOut">
              <a:rPr lang="ca-ES" smtClean="0"/>
              <a:t>6/8/2024</a:t>
            </a:fld>
            <a:endParaRPr lang="ca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FE8945-19B6-464E-93F7-C78A7EC10078}" type="slidenum">
              <a:rPr lang="ca-ES" smtClean="0"/>
              <a:t>‹Nº›</a:t>
            </a:fld>
            <a:endParaRPr lang="ca-E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ca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ca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3B5ABB-FBC5-4EF4-AFCB-CE15EC0E6C6E}" type="datetimeFigureOut">
              <a:rPr lang="ca-ES" smtClean="0"/>
              <a:t>6/8/2024</a:t>
            </a:fld>
            <a:endParaRPr lang="ca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FE8945-19B6-464E-93F7-C78A7EC10078}" type="slidenum">
              <a:rPr lang="ca-ES" smtClean="0"/>
              <a:t>‹Nº›</a:t>
            </a:fld>
            <a:endParaRPr lang="ca-E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/>
              <a:t>Haga clic para modificar el estilo de título del patrón</a:t>
            </a:r>
            <a:endParaRPr lang="ca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3B5ABB-FBC5-4EF4-AFCB-CE15EC0E6C6E}" type="datetimeFigureOut">
              <a:rPr lang="ca-ES" smtClean="0"/>
              <a:t>6/8/2024</a:t>
            </a:fld>
            <a:endParaRPr lang="ca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FE8945-19B6-464E-93F7-C78A7EC10078}" type="slidenum">
              <a:rPr lang="ca-ES" smtClean="0"/>
              <a:t>‹Nº›</a:t>
            </a:fld>
            <a:endParaRPr lang="ca-E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ca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ca-E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ca-E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3B5ABB-FBC5-4EF4-AFCB-CE15EC0E6C6E}" type="datetimeFigureOut">
              <a:rPr lang="ca-ES" smtClean="0"/>
              <a:t>6/8/2024</a:t>
            </a:fld>
            <a:endParaRPr lang="ca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FE8945-19B6-464E-93F7-C78A7EC10078}" type="slidenum">
              <a:rPr lang="ca-ES" smtClean="0"/>
              <a:t>‹Nº›</a:t>
            </a:fld>
            <a:endParaRPr lang="ca-E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s-ES"/>
              <a:t>Haga clic para modificar el estilo de título del patrón</a:t>
            </a:r>
            <a:endParaRPr lang="ca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ca-E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ca-E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3B5ABB-FBC5-4EF4-AFCB-CE15EC0E6C6E}" type="datetimeFigureOut">
              <a:rPr lang="ca-ES" smtClean="0"/>
              <a:t>6/8/2024</a:t>
            </a:fld>
            <a:endParaRPr lang="ca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FE8945-19B6-464E-93F7-C78A7EC10078}" type="slidenum">
              <a:rPr lang="ca-ES" smtClean="0"/>
              <a:t>‹Nº›</a:t>
            </a:fld>
            <a:endParaRPr lang="ca-E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ca-E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3B5ABB-FBC5-4EF4-AFCB-CE15EC0E6C6E}" type="datetimeFigureOut">
              <a:rPr lang="ca-ES" smtClean="0"/>
              <a:t>6/8/2024</a:t>
            </a:fld>
            <a:endParaRPr lang="ca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FE8945-19B6-464E-93F7-C78A7EC10078}" type="slidenum">
              <a:rPr lang="ca-ES" smtClean="0"/>
              <a:t>‹Nº›</a:t>
            </a:fld>
            <a:endParaRPr lang="ca-E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3B5ABB-FBC5-4EF4-AFCB-CE15EC0E6C6E}" type="datetimeFigureOut">
              <a:rPr lang="ca-ES" smtClean="0"/>
              <a:t>6/8/2024</a:t>
            </a:fld>
            <a:endParaRPr lang="ca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FE8945-19B6-464E-93F7-C78A7EC10078}" type="slidenum">
              <a:rPr lang="ca-ES" smtClean="0"/>
              <a:t>‹Nº›</a:t>
            </a:fld>
            <a:endParaRPr lang="ca-E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  <a:endParaRPr lang="ca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ca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3B5ABB-FBC5-4EF4-AFCB-CE15EC0E6C6E}" type="datetimeFigureOut">
              <a:rPr lang="ca-ES" smtClean="0"/>
              <a:t>6/8/2024</a:t>
            </a:fld>
            <a:endParaRPr lang="ca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FE8945-19B6-464E-93F7-C78A7EC10078}" type="slidenum">
              <a:rPr lang="ca-ES" smtClean="0"/>
              <a:t>‹Nº›</a:t>
            </a:fld>
            <a:endParaRPr lang="ca-E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  <a:endParaRPr lang="ca-E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ca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3B5ABB-FBC5-4EF4-AFCB-CE15EC0E6C6E}" type="datetimeFigureOut">
              <a:rPr lang="ca-ES" smtClean="0"/>
              <a:t>6/8/2024</a:t>
            </a:fld>
            <a:endParaRPr lang="ca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FE8945-19B6-464E-93F7-C78A7EC10078}" type="slidenum">
              <a:rPr lang="ca-ES" smtClean="0"/>
              <a:t>‹Nº›</a:t>
            </a:fld>
            <a:endParaRPr lang="ca-E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ca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ca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3B5ABB-FBC5-4EF4-AFCB-CE15EC0E6C6E}" type="datetimeFigureOut">
              <a:rPr lang="ca-ES" smtClean="0"/>
              <a:t>6/8/2024</a:t>
            </a:fld>
            <a:endParaRPr lang="ca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ca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FE8945-19B6-464E-93F7-C78A7EC10078}" type="slidenum">
              <a:rPr lang="ca-ES" smtClean="0"/>
              <a:t>‹Nº›</a:t>
            </a:fld>
            <a:endParaRPr lang="ca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ca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upo 7">
            <a:extLst>
              <a:ext uri="{FF2B5EF4-FFF2-40B4-BE49-F238E27FC236}">
                <a16:creationId xmlns:a16="http://schemas.microsoft.com/office/drawing/2014/main" id="{E592DAE8-756E-65CD-4AC1-0DF691673097}"/>
              </a:ext>
            </a:extLst>
          </p:cNvPr>
          <p:cNvGrpSpPr/>
          <p:nvPr/>
        </p:nvGrpSpPr>
        <p:grpSpPr>
          <a:xfrm>
            <a:off x="1844824" y="2915816"/>
            <a:ext cx="2769501" cy="2958960"/>
            <a:chOff x="1916832" y="3059832"/>
            <a:chExt cx="2769501" cy="2958960"/>
          </a:xfrm>
        </p:grpSpPr>
        <p:pic>
          <p:nvPicPr>
            <p:cNvPr id="42" name="Imagen 41">
              <a:extLst>
                <a:ext uri="{FF2B5EF4-FFF2-40B4-BE49-F238E27FC236}">
                  <a16:creationId xmlns:a16="http://schemas.microsoft.com/office/drawing/2014/main" id="{1156A7CC-F5FC-DC32-1096-24C46C79A36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12205" r="28793"/>
            <a:stretch/>
          </p:blipFill>
          <p:spPr>
            <a:xfrm>
              <a:off x="2276872" y="3059832"/>
              <a:ext cx="2409461" cy="2958960"/>
            </a:xfrm>
            <a:prstGeom prst="rect">
              <a:avLst/>
            </a:prstGeom>
          </p:spPr>
        </p:pic>
        <p:sp>
          <p:nvSpPr>
            <p:cNvPr id="28" name="CuadroTexto 27">
              <a:extLst>
                <a:ext uri="{FF2B5EF4-FFF2-40B4-BE49-F238E27FC236}">
                  <a16:creationId xmlns:a16="http://schemas.microsoft.com/office/drawing/2014/main" id="{EDA0AE96-4F12-BB4F-7265-D023FD35E0C6}"/>
                </a:ext>
              </a:extLst>
            </p:cNvPr>
            <p:cNvSpPr txBox="1"/>
            <p:nvPr/>
          </p:nvSpPr>
          <p:spPr>
            <a:xfrm>
              <a:off x="1916832" y="3386434"/>
              <a:ext cx="48900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</p:grpSp>
      <p:grpSp>
        <p:nvGrpSpPr>
          <p:cNvPr id="5" name="Grupo 4">
            <a:extLst>
              <a:ext uri="{FF2B5EF4-FFF2-40B4-BE49-F238E27FC236}">
                <a16:creationId xmlns:a16="http://schemas.microsoft.com/office/drawing/2014/main" id="{7E4FF805-E153-9BEE-A43A-0F1FEFAEB365}"/>
              </a:ext>
            </a:extLst>
          </p:cNvPr>
          <p:cNvGrpSpPr/>
          <p:nvPr/>
        </p:nvGrpSpPr>
        <p:grpSpPr>
          <a:xfrm>
            <a:off x="1916832" y="67170"/>
            <a:ext cx="2571555" cy="3219131"/>
            <a:chOff x="1340768" y="251520"/>
            <a:chExt cx="2571555" cy="3219131"/>
          </a:xfrm>
        </p:grpSpPr>
        <p:sp>
          <p:nvSpPr>
            <p:cNvPr id="27" name="CuadroTexto 26">
              <a:extLst>
                <a:ext uri="{FF2B5EF4-FFF2-40B4-BE49-F238E27FC236}">
                  <a16:creationId xmlns:a16="http://schemas.microsoft.com/office/drawing/2014/main" id="{368DCCC4-21D6-4DCC-0EA6-63DCAFCEB277}"/>
                </a:ext>
              </a:extLst>
            </p:cNvPr>
            <p:cNvSpPr txBox="1"/>
            <p:nvPr/>
          </p:nvSpPr>
          <p:spPr>
            <a:xfrm>
              <a:off x="1340768" y="251520"/>
              <a:ext cx="40524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38" name="24 CuadroTexto">
              <a:extLst>
                <a:ext uri="{FF2B5EF4-FFF2-40B4-BE49-F238E27FC236}">
                  <a16:creationId xmlns:a16="http://schemas.microsoft.com/office/drawing/2014/main" id="{AA5F2D58-2E18-3612-0BCB-AB806E937B74}"/>
                </a:ext>
              </a:extLst>
            </p:cNvPr>
            <p:cNvSpPr txBox="1"/>
            <p:nvPr/>
          </p:nvSpPr>
          <p:spPr>
            <a:xfrm rot="16200000">
              <a:off x="1484873" y="836472"/>
              <a:ext cx="679596" cy="24932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/>
                <a:t>Low Pi</a:t>
              </a:r>
            </a:p>
          </p:txBody>
        </p:sp>
        <p:sp>
          <p:nvSpPr>
            <p:cNvPr id="39" name="25 CuadroTexto">
              <a:extLst>
                <a:ext uri="{FF2B5EF4-FFF2-40B4-BE49-F238E27FC236}">
                  <a16:creationId xmlns:a16="http://schemas.microsoft.com/office/drawing/2014/main" id="{8035E6EE-A0F8-55AA-79FC-43A7ED2C7ACA}"/>
                </a:ext>
              </a:extLst>
            </p:cNvPr>
            <p:cNvSpPr txBox="1"/>
            <p:nvPr/>
          </p:nvSpPr>
          <p:spPr>
            <a:xfrm rot="16200000">
              <a:off x="1335269" y="2184118"/>
              <a:ext cx="97550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/>
                <a:t>Sufficient Pi </a:t>
              </a:r>
            </a:p>
          </p:txBody>
        </p:sp>
        <p:grpSp>
          <p:nvGrpSpPr>
            <p:cNvPr id="4" name="Grupo 3">
              <a:extLst>
                <a:ext uri="{FF2B5EF4-FFF2-40B4-BE49-F238E27FC236}">
                  <a16:creationId xmlns:a16="http://schemas.microsoft.com/office/drawing/2014/main" id="{BC82D06F-1987-3070-54B8-7593318E875A}"/>
                </a:ext>
              </a:extLst>
            </p:cNvPr>
            <p:cNvGrpSpPr/>
            <p:nvPr/>
          </p:nvGrpSpPr>
          <p:grpSpPr>
            <a:xfrm>
              <a:off x="1988840" y="382769"/>
              <a:ext cx="1923483" cy="3087882"/>
              <a:chOff x="1988840" y="382769"/>
              <a:chExt cx="1923483" cy="3087882"/>
            </a:xfrm>
          </p:grpSpPr>
          <p:sp>
            <p:nvSpPr>
              <p:cNvPr id="33" name="19 CuadroTexto">
                <a:extLst>
                  <a:ext uri="{FF2B5EF4-FFF2-40B4-BE49-F238E27FC236}">
                    <a16:creationId xmlns:a16="http://schemas.microsoft.com/office/drawing/2014/main" id="{1F0A100E-8BB9-9885-E7CB-D6E8BCD2B4BC}"/>
                  </a:ext>
                </a:extLst>
              </p:cNvPr>
              <p:cNvSpPr txBox="1"/>
              <p:nvPr/>
            </p:nvSpPr>
            <p:spPr>
              <a:xfrm>
                <a:off x="2077988" y="2993061"/>
                <a:ext cx="66529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="1" dirty="0"/>
                  <a:t>WT</a:t>
                </a:r>
              </a:p>
            </p:txBody>
          </p:sp>
          <p:sp>
            <p:nvSpPr>
              <p:cNvPr id="34" name="20 CuadroTexto">
                <a:extLst>
                  <a:ext uri="{FF2B5EF4-FFF2-40B4-BE49-F238E27FC236}">
                    <a16:creationId xmlns:a16="http://schemas.microsoft.com/office/drawing/2014/main" id="{5CD09F61-0E4B-6DA3-28CD-2DB9814360CB}"/>
                  </a:ext>
                </a:extLst>
              </p:cNvPr>
              <p:cNvSpPr txBox="1"/>
              <p:nvPr/>
            </p:nvSpPr>
            <p:spPr>
              <a:xfrm>
                <a:off x="2682074" y="2993061"/>
                <a:ext cx="591301" cy="24932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="1" dirty="0"/>
                  <a:t>23.5</a:t>
                </a:r>
              </a:p>
            </p:txBody>
          </p:sp>
          <p:sp>
            <p:nvSpPr>
              <p:cNvPr id="35" name="21 CuadroTexto">
                <a:extLst>
                  <a:ext uri="{FF2B5EF4-FFF2-40B4-BE49-F238E27FC236}">
                    <a16:creationId xmlns:a16="http://schemas.microsoft.com/office/drawing/2014/main" id="{77BA0B97-8554-30F1-FC88-A57A08BE5756}"/>
                  </a:ext>
                </a:extLst>
              </p:cNvPr>
              <p:cNvSpPr txBox="1"/>
              <p:nvPr/>
            </p:nvSpPr>
            <p:spPr>
              <a:xfrm>
                <a:off x="3260589" y="2992017"/>
                <a:ext cx="62965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="1" dirty="0"/>
                  <a:t>38.7</a:t>
                </a:r>
              </a:p>
            </p:txBody>
          </p:sp>
          <p:cxnSp>
            <p:nvCxnSpPr>
              <p:cNvPr id="36" name="22 Conector recto">
                <a:extLst>
                  <a:ext uri="{FF2B5EF4-FFF2-40B4-BE49-F238E27FC236}">
                    <a16:creationId xmlns:a16="http://schemas.microsoft.com/office/drawing/2014/main" id="{78555B0A-FA21-633A-CC38-BBC56041C8C0}"/>
                  </a:ext>
                </a:extLst>
              </p:cNvPr>
              <p:cNvCxnSpPr/>
              <p:nvPr/>
            </p:nvCxnSpPr>
            <p:spPr>
              <a:xfrm>
                <a:off x="2738759" y="3209453"/>
                <a:ext cx="1094783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7" name="23 CuadroTexto">
                <a:extLst>
                  <a:ext uri="{FF2B5EF4-FFF2-40B4-BE49-F238E27FC236}">
                    <a16:creationId xmlns:a16="http://schemas.microsoft.com/office/drawing/2014/main" id="{8C358693-D21D-3C12-C442-EC112B1EB1DB}"/>
                  </a:ext>
                </a:extLst>
              </p:cNvPr>
              <p:cNvSpPr txBox="1"/>
              <p:nvPr/>
            </p:nvSpPr>
            <p:spPr>
              <a:xfrm>
                <a:off x="2670139" y="3224430"/>
                <a:ext cx="12421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="1" dirty="0"/>
                  <a:t>CRISPR-miR827</a:t>
                </a:r>
              </a:p>
            </p:txBody>
          </p:sp>
          <p:pic>
            <p:nvPicPr>
              <p:cNvPr id="40" name="Picture 2" descr="P:\Documentos proyecto\Arroz\Experimento lineas KO mir399 y miR827\Caracterización 1 Lineas KO399 y KO827\Lineas OE y CRISPR 2019-04-15\DSC_7048.JPG">
                <a:extLst>
                  <a:ext uri="{FF2B5EF4-FFF2-40B4-BE49-F238E27FC236}">
                    <a16:creationId xmlns:a16="http://schemas.microsoft.com/office/drawing/2014/main" id="{E017393E-323F-3AC8-F96E-C130FA660CCA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3" cstate="print"/>
              <a:srcRect l="26247" t="23936" r="21237" b="13095"/>
              <a:stretch/>
            </p:blipFill>
            <p:spPr bwMode="auto">
              <a:xfrm>
                <a:off x="2007612" y="1743879"/>
                <a:ext cx="1901441" cy="1296152"/>
              </a:xfrm>
              <a:prstGeom prst="rect">
                <a:avLst/>
              </a:prstGeom>
              <a:noFill/>
            </p:spPr>
          </p:pic>
          <p:pic>
            <p:nvPicPr>
              <p:cNvPr id="41" name="Picture 3" descr="P:\Documentos proyecto\Arroz\Experimento lineas KO mir399 y miR827\Caracterización 1 Lineas KO399 y KO827\Lineas OE y CRISPR 2019-04-15\DSC_7055.JPG">
                <a:extLst>
                  <a:ext uri="{FF2B5EF4-FFF2-40B4-BE49-F238E27FC236}">
                    <a16:creationId xmlns:a16="http://schemas.microsoft.com/office/drawing/2014/main" id="{66590995-33BD-5D20-BBCA-BCB238631CE8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4" cstate="print"/>
              <a:srcRect l="37787" t="35516" r="23635" b="11648"/>
              <a:stretch/>
            </p:blipFill>
            <p:spPr bwMode="auto">
              <a:xfrm>
                <a:off x="1988840" y="382769"/>
                <a:ext cx="1901441" cy="1296152"/>
              </a:xfrm>
              <a:prstGeom prst="rect">
                <a:avLst/>
              </a:prstGeom>
              <a:noFill/>
            </p:spPr>
          </p:pic>
        </p:grpSp>
      </p:grpSp>
      <p:grpSp>
        <p:nvGrpSpPr>
          <p:cNvPr id="6" name="Grupo 5">
            <a:extLst>
              <a:ext uri="{FF2B5EF4-FFF2-40B4-BE49-F238E27FC236}">
                <a16:creationId xmlns:a16="http://schemas.microsoft.com/office/drawing/2014/main" id="{CFA87931-F3D5-03F3-A08D-2C08B2FC7F0C}"/>
              </a:ext>
            </a:extLst>
          </p:cNvPr>
          <p:cNvGrpSpPr/>
          <p:nvPr/>
        </p:nvGrpSpPr>
        <p:grpSpPr>
          <a:xfrm>
            <a:off x="1916832" y="5382582"/>
            <a:ext cx="2490593" cy="2141746"/>
            <a:chOff x="1340768" y="6012160"/>
            <a:chExt cx="2490593" cy="2141746"/>
          </a:xfrm>
        </p:grpSpPr>
        <p:pic>
          <p:nvPicPr>
            <p:cNvPr id="2" name="Imagen 1" descr="Gráfico, Gráfico de barras&#10;&#10;Descripción generada automáticamente">
              <a:extLst>
                <a:ext uri="{FF2B5EF4-FFF2-40B4-BE49-F238E27FC236}">
                  <a16:creationId xmlns:a16="http://schemas.microsoft.com/office/drawing/2014/main" id="{78922721-E4C9-1DBD-A2D0-3D384AD26340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628800" y="6012160"/>
              <a:ext cx="2202561" cy="2141746"/>
            </a:xfrm>
            <a:prstGeom prst="rect">
              <a:avLst/>
            </a:prstGeom>
          </p:spPr>
        </p:pic>
        <p:sp>
          <p:nvSpPr>
            <p:cNvPr id="3" name="CuadroTexto 2">
              <a:extLst>
                <a:ext uri="{FF2B5EF4-FFF2-40B4-BE49-F238E27FC236}">
                  <a16:creationId xmlns:a16="http://schemas.microsoft.com/office/drawing/2014/main" id="{0513A20E-AD37-3063-23AD-03665932B224}"/>
                </a:ext>
              </a:extLst>
            </p:cNvPr>
            <p:cNvSpPr txBox="1"/>
            <p:nvPr/>
          </p:nvSpPr>
          <p:spPr>
            <a:xfrm>
              <a:off x="1340768" y="6044098"/>
              <a:ext cx="48900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</p:grpSp>
      <p:sp>
        <p:nvSpPr>
          <p:cNvPr id="7" name="CuadroTexto 6">
            <a:extLst>
              <a:ext uri="{FF2B5EF4-FFF2-40B4-BE49-F238E27FC236}">
                <a16:creationId xmlns:a16="http://schemas.microsoft.com/office/drawing/2014/main" id="{587457EF-F916-1023-CD9C-7D636C611ED0}"/>
              </a:ext>
            </a:extLst>
          </p:cNvPr>
          <p:cNvSpPr txBox="1"/>
          <p:nvPr/>
        </p:nvSpPr>
        <p:spPr>
          <a:xfrm>
            <a:off x="836712" y="7420669"/>
            <a:ext cx="5760640" cy="16158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spcAft>
                <a:spcPts val="1000"/>
              </a:spcAft>
            </a:pPr>
            <a:r>
              <a:rPr lang="en-US" sz="1100" b="1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. S5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r>
              <a:rPr lang="en-US" sz="1100" b="1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ppearance of CRISPR-miR827 rice plants and expression analysis of </a:t>
            </a:r>
            <a:r>
              <a:rPr lang="en-US" sz="1100" i="1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sPHR4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</a:t>
            </a:r>
            <a:r>
              <a:rPr lang="en-US" sz="1100" i="1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sSPX-MFS3</a:t>
            </a:r>
            <a:r>
              <a:rPr lang="en-US" sz="110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 CRISPR-miR827 plants. </a:t>
            </a:r>
            <a:r>
              <a:rPr lang="en-US" sz="1100" b="1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. 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henotype of CRISPR-miR827 (lines 23.5 and 38.7) and wild-type (WT, e.g. azygous plants segregated from heterozygous plants) plants. Rice plants were grown under Pi-limiting conditions (Low-Pi) or Pi sufficient conditions for 3 weeks. </a:t>
            </a:r>
            <a:r>
              <a:rPr lang="en-US" sz="1100" b="1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. </a:t>
            </a:r>
            <a:r>
              <a:rPr lang="en-US" sz="1100" i="1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sPHR4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expression in wild-type and CRISPR-miR827 rice plants grown under Low-Pi supply (black bars) and normal (white bars) Pi conditions. </a:t>
            </a:r>
            <a:r>
              <a:rPr lang="en-US" sz="1100" b="1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. </a:t>
            </a:r>
            <a:r>
              <a:rPr lang="en-US" sz="1100" i="1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sSPX-MFS3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expression in CRISPR-miR827 plants was determined by RT-qPCR. Data from one representative experiment of three independent experiments are presented, each experiment consisting of a pool of 3 leaves (ANOVA test, * P ≤ 0.05; ** P ≤ 0.01; *** P ≤ 0.001; ns, not </a:t>
            </a:r>
            <a:r>
              <a:rPr lang="en-US" sz="1100" kern="10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ignificant).</a:t>
            </a:r>
            <a:endParaRPr lang="en-US" sz="1100" kern="1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89</TotalTime>
  <Words>162</Words>
  <Application>Microsoft Office PowerPoint</Application>
  <PresentationFormat>Presentación en pantalla (4:3)</PresentationFormat>
  <Paragraphs>10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Tema de Office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Mireia Bundó Barberà</dc:creator>
  <cp:lastModifiedBy>Blanca San Segundo de los Mozos</cp:lastModifiedBy>
  <cp:revision>53</cp:revision>
  <cp:lastPrinted>2024-05-31T15:09:44Z</cp:lastPrinted>
  <dcterms:created xsi:type="dcterms:W3CDTF">2022-09-07T16:12:01Z</dcterms:created>
  <dcterms:modified xsi:type="dcterms:W3CDTF">2024-08-06T07:11:53Z</dcterms:modified>
</cp:coreProperties>
</file>